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2B4F3A7-DE97-1452-062E-205CDFD20507}" name="Mary Richardson" initials="MR" userId="S::mrichardson@edanz.com::a7d58eae-e417-4395-9755-5887d7f9537d" providerId="AD"/>
  <p188:author id="{FFE47EE6-A2F0-13A5-8EE8-3661DB1849A6}" name="Medical Writer" initials="MW" userId="Medical Write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94660"/>
  </p:normalViewPr>
  <p:slideViewPr>
    <p:cSldViewPr snapToGrid="0">
      <p:cViewPr varScale="1">
        <p:scale>
          <a:sx n="75" d="100"/>
          <a:sy n="75" d="100"/>
        </p:scale>
        <p:origin x="6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8414A4-B82A-F3E8-B127-4D8F3A85D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47F5F0-C6E3-AB43-92BC-02616D36E1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32E555-FECD-504A-85E5-2D54D8A56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22AD92-3DFF-7826-217E-6B65BA5DD2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F69E33-88EA-8004-CCF5-C5C1EF47E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803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3E8C0E-22B1-8721-2135-D64851E617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CFCDDB-FD1F-5110-41A6-DFA0B73131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568319-74E9-AFEF-2B24-B094F1629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02629B-0EEE-8A8B-4008-850CB1C13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FA62A6-D44F-2398-4F26-A20C66A0E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219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0387BE-CC7C-737D-A886-0AED63F53E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75BFE1-6439-0B99-9B50-360363B95C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7BF975-AAB4-5F58-9FA6-6DF67FF69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CDF480-4811-6C0C-1F02-906F490399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608122-C955-02D9-91F2-A31724F0F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461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BF080-F810-7246-F7B9-61BF23198C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6C7610-7951-F5E7-7EF6-C6B163780D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847625-FC93-421A-36B2-CAE2B53AF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47C515-BC25-7C3C-15DC-098A9215A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787FF5-BDBF-5E43-C4F4-B480714C2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142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55AC1-775F-8550-81A0-940D55E52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D3B888-249C-4FB1-5CDA-ED7879FFB1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4DAE23-1FD8-2453-F8A2-B2570A21A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CB4419-209E-2FFE-F047-9F70CFF81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5DE53A-2C08-B235-0738-85079CF0B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486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EFB491-3B20-1E9C-8AEF-DDAD695C8D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023E97-779A-F4B1-6EF5-726D0BC2F0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062E1D-6EB3-1AAD-09F6-987679693B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13987C-F950-F68C-1836-2EDAF785C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5BCBBF-1FCF-43B7-49F5-AEE888F11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EAC911-2FB7-512D-4C03-0ACCEEC59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933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B4243-E2AF-7299-221D-4E39DB29A8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466C5E-4BB8-0B90-7515-07241959C0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FDCB2E-EF91-0415-FD97-C48217037A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AA18A9-CD9A-0863-0169-DEA47E5C1F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DB0F00-86FD-60E2-CA9B-0D0C307CC7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16556C-C02C-220B-07B6-3CB438606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32FBAAC-CC0E-6C57-8393-FACA4EE0D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BB2EB6-F6B8-9E12-3D5C-FEC305F37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812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15FE24-E91E-E3B4-C394-FC234150D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4AB112-FB04-439C-E8BA-B367A740C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A8AA52-A0A1-D914-3B2C-687683A2B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DABA35B-6FEA-E60B-FD36-DE1D6AB6A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403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1D9FC0-597A-1BA9-7A4C-E8D1118BB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11032AC-E442-80D8-858D-315A89224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AE06F6-4A87-4FEE-0397-BAA21A02E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271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AD2E5-7216-503A-1BEF-618DD87A3D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79D487-1241-28D7-219E-2899C9B8ED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23989C-D183-6BD0-53E7-E41A674AB8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C7EDC2-03C6-B220-B430-D86DA1631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3B1B29-D33D-44EB-C595-2B27974CC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B7212A-39CD-99CC-E13D-BE97FDE7D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535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2975E-A70F-7F38-120B-D3EB2ECADD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364B4A0-FC58-7324-5FB0-7769C80B3A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6628E9-D94A-FA98-82B5-B78FB29727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AC1EC9-F357-8D6C-CC95-6CBB36EBAC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21665C-64E4-5AF6-D0D1-8C458F68A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9D22D6-37A9-3F6B-F286-758869390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394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85FA3B-D782-C694-8AD5-9B945847F3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B4B71D-AE6F-DBFA-C1A8-0066CE0957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0DD2F9-E0DC-8449-EAF9-3471024395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CEA5D0-8E18-4B04-BCB9-E9B1587BF2A0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E52A73-38C7-312F-F221-BF3C731799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FD0F0C-D3DC-76D9-05BA-EEB2261630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99507-ADA7-48FA-91A9-ED6A4189A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010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8ABC712-FE2E-8B7F-0242-1EA2748F3EDB}"/>
              </a:ext>
            </a:extLst>
          </p:cNvPr>
          <p:cNvSpPr txBox="1"/>
          <p:nvPr/>
        </p:nvSpPr>
        <p:spPr>
          <a:xfrm>
            <a:off x="0" y="0"/>
            <a:ext cx="10310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b="1" dirty="0"/>
              <a:t>Supplementary </a:t>
            </a:r>
            <a:r>
              <a:rPr lang="en-NZ" b="1" dirty="0" smtClean="0"/>
              <a:t>Figure </a:t>
            </a:r>
            <a:r>
              <a:rPr lang="en-NZ" b="1" dirty="0"/>
              <a:t>1.</a:t>
            </a:r>
            <a:r>
              <a:rPr lang="en-NZ" dirty="0"/>
              <a:t> Study design</a:t>
            </a:r>
            <a:endParaRPr lang="en-US" dirty="0"/>
          </a:p>
        </p:txBody>
      </p:sp>
      <p:sp>
        <p:nvSpPr>
          <p:cNvPr id="6" name="矩形 98">
            <a:extLst>
              <a:ext uri="{FF2B5EF4-FFF2-40B4-BE49-F238E27FC236}">
                <a16:creationId xmlns:a16="http://schemas.microsoft.com/office/drawing/2014/main" id="{4B782F4F-CDD3-52F6-75D3-617CC969615F}"/>
              </a:ext>
            </a:extLst>
          </p:cNvPr>
          <p:cNvSpPr/>
          <p:nvPr/>
        </p:nvSpPr>
        <p:spPr>
          <a:xfrm>
            <a:off x="217170" y="2229719"/>
            <a:ext cx="3332892" cy="205718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ey inclusion criteria:</a:t>
            </a:r>
          </a:p>
          <a:p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ge IIIB–IV non-squamous NSCLC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emotherapy-naïv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R-TKI failure*</a:t>
            </a:r>
            <a:r>
              <a:rPr lang="zh-CN" alt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NZ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COG performance status 0–1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 expression ≥ 1%</a:t>
            </a:r>
            <a:r>
              <a:rPr lang="en-US" altLang="zh-CN" sz="14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</a:p>
          <a:p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9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99">
            <a:extLst>
              <a:ext uri="{FF2B5EF4-FFF2-40B4-BE49-F238E27FC236}">
                <a16:creationId xmlns:a16="http://schemas.microsoft.com/office/drawing/2014/main" id="{E78D93B4-BB86-BCFF-CE4E-13D0D6F4350E}"/>
              </a:ext>
            </a:extLst>
          </p:cNvPr>
          <p:cNvSpPr/>
          <p:nvPr/>
        </p:nvSpPr>
        <p:spPr>
          <a:xfrm>
            <a:off x="3783469" y="2575950"/>
            <a:ext cx="1420042" cy="136457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ezolizumab</a:t>
            </a:r>
          </a:p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00 mg plus</a:t>
            </a:r>
          </a:p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vacizumab</a:t>
            </a:r>
          </a:p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mg/kg, Q3W</a:t>
            </a:r>
            <a:r>
              <a:rPr lang="en-US" altLang="zh-CN" sz="14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</a:p>
        </p:txBody>
      </p:sp>
      <p:cxnSp>
        <p:nvCxnSpPr>
          <p:cNvPr id="8" name="直接箭头连接符 100">
            <a:extLst>
              <a:ext uri="{FF2B5EF4-FFF2-40B4-BE49-F238E27FC236}">
                <a16:creationId xmlns:a16="http://schemas.microsoft.com/office/drawing/2014/main" id="{CB00B112-86D1-929E-097C-26371711A1C1}"/>
              </a:ext>
            </a:extLst>
          </p:cNvPr>
          <p:cNvCxnSpPr>
            <a:cxnSpLocks/>
            <a:stCxn id="6" idx="3"/>
            <a:endCxn id="7" idx="1"/>
          </p:cNvCxnSpPr>
          <p:nvPr/>
        </p:nvCxnSpPr>
        <p:spPr>
          <a:xfrm flipV="1">
            <a:off x="3550062" y="3258236"/>
            <a:ext cx="233407" cy="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矩形 101">
            <a:extLst>
              <a:ext uri="{FF2B5EF4-FFF2-40B4-BE49-F238E27FC236}">
                <a16:creationId xmlns:a16="http://schemas.microsoft.com/office/drawing/2014/main" id="{6E9A21B9-58BE-300C-A69B-AEFFC1167BF3}"/>
              </a:ext>
            </a:extLst>
          </p:cNvPr>
          <p:cNvSpPr/>
          <p:nvPr/>
        </p:nvSpPr>
        <p:spPr>
          <a:xfrm>
            <a:off x="5460027" y="2873130"/>
            <a:ext cx="1125562" cy="75468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gt; 6 CR/PR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102">
            <a:extLst>
              <a:ext uri="{FF2B5EF4-FFF2-40B4-BE49-F238E27FC236}">
                <a16:creationId xmlns:a16="http://schemas.microsoft.com/office/drawing/2014/main" id="{D1182433-8015-8D87-B374-25351FC178AA}"/>
              </a:ext>
            </a:extLst>
          </p:cNvPr>
          <p:cNvSpPr/>
          <p:nvPr/>
        </p:nvSpPr>
        <p:spPr>
          <a:xfrm>
            <a:off x="5460027" y="1660252"/>
            <a:ext cx="1125562" cy="75468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≤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 CR/PR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肘形连接符 103">
            <a:extLst>
              <a:ext uri="{FF2B5EF4-FFF2-40B4-BE49-F238E27FC236}">
                <a16:creationId xmlns:a16="http://schemas.microsoft.com/office/drawing/2014/main" id="{35B4BE10-86EE-4B78-D413-9E590F66D732}"/>
              </a:ext>
            </a:extLst>
          </p:cNvPr>
          <p:cNvCxnSpPr>
            <a:cxnSpLocks/>
            <a:endCxn id="10" idx="1"/>
          </p:cNvCxnSpPr>
          <p:nvPr/>
        </p:nvCxnSpPr>
        <p:spPr>
          <a:xfrm flipV="1">
            <a:off x="5260661" y="2037594"/>
            <a:ext cx="199366" cy="1220642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04">
            <a:extLst>
              <a:ext uri="{FF2B5EF4-FFF2-40B4-BE49-F238E27FC236}">
                <a16:creationId xmlns:a16="http://schemas.microsoft.com/office/drawing/2014/main" id="{43F56849-46BA-B3AA-D7AD-22DFAC13C939}"/>
              </a:ext>
            </a:extLst>
          </p:cNvPr>
          <p:cNvCxnSpPr>
            <a:cxnSpLocks/>
            <a:stCxn id="7" idx="3"/>
            <a:endCxn id="9" idx="1"/>
          </p:cNvCxnSpPr>
          <p:nvPr/>
        </p:nvCxnSpPr>
        <p:spPr>
          <a:xfrm flipV="1">
            <a:off x="5203511" y="3250472"/>
            <a:ext cx="256516" cy="77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矩形 105">
            <a:extLst>
              <a:ext uri="{FF2B5EF4-FFF2-40B4-BE49-F238E27FC236}">
                <a16:creationId xmlns:a16="http://schemas.microsoft.com/office/drawing/2014/main" id="{4AEC673E-7A40-FA8B-7496-39F5B3440C02}"/>
              </a:ext>
            </a:extLst>
          </p:cNvPr>
          <p:cNvSpPr/>
          <p:nvPr/>
        </p:nvSpPr>
        <p:spPr>
          <a:xfrm>
            <a:off x="6760188" y="1660252"/>
            <a:ext cx="1497037" cy="75468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y closed for futility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06">
            <a:extLst>
              <a:ext uri="{FF2B5EF4-FFF2-40B4-BE49-F238E27FC236}">
                <a16:creationId xmlns:a16="http://schemas.microsoft.com/office/drawing/2014/main" id="{1F71E0E8-D640-9560-A321-8D87DAC4B732}"/>
              </a:ext>
            </a:extLst>
          </p:cNvPr>
          <p:cNvSpPr/>
          <p:nvPr/>
        </p:nvSpPr>
        <p:spPr>
          <a:xfrm>
            <a:off x="6760188" y="2756163"/>
            <a:ext cx="1497037" cy="978134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roll a further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patients</a:t>
            </a:r>
          </a:p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39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箭头连接符 107">
            <a:extLst>
              <a:ext uri="{FF2B5EF4-FFF2-40B4-BE49-F238E27FC236}">
                <a16:creationId xmlns:a16="http://schemas.microsoft.com/office/drawing/2014/main" id="{35FAC039-C563-FCA0-19DF-6C550A3A9A3F}"/>
              </a:ext>
            </a:extLst>
          </p:cNvPr>
          <p:cNvCxnSpPr>
            <a:stCxn id="9" idx="3"/>
            <a:endCxn id="14" idx="1"/>
          </p:cNvCxnSpPr>
          <p:nvPr/>
        </p:nvCxnSpPr>
        <p:spPr>
          <a:xfrm flipV="1">
            <a:off x="6585590" y="3245231"/>
            <a:ext cx="174598" cy="52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08">
            <a:extLst>
              <a:ext uri="{FF2B5EF4-FFF2-40B4-BE49-F238E27FC236}">
                <a16:creationId xmlns:a16="http://schemas.microsoft.com/office/drawing/2014/main" id="{A3C2BA25-B832-E37E-0460-CB5D5E13C669}"/>
              </a:ext>
            </a:extLst>
          </p:cNvPr>
          <p:cNvCxnSpPr>
            <a:stCxn id="10" idx="3"/>
            <a:endCxn id="13" idx="1"/>
          </p:cNvCxnSpPr>
          <p:nvPr/>
        </p:nvCxnSpPr>
        <p:spPr>
          <a:xfrm>
            <a:off x="6585590" y="2037594"/>
            <a:ext cx="1745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矩形 109">
            <a:extLst>
              <a:ext uri="{FF2B5EF4-FFF2-40B4-BE49-F238E27FC236}">
                <a16:creationId xmlns:a16="http://schemas.microsoft.com/office/drawing/2014/main" id="{E404C97B-4904-80B6-B61A-4553D32C89FB}"/>
              </a:ext>
            </a:extLst>
          </p:cNvPr>
          <p:cNvSpPr/>
          <p:nvPr/>
        </p:nvSpPr>
        <p:spPr>
          <a:xfrm>
            <a:off x="8625977" y="2468077"/>
            <a:ext cx="1158855" cy="662696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≤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 CR/PR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10">
            <a:extLst>
              <a:ext uri="{FF2B5EF4-FFF2-40B4-BE49-F238E27FC236}">
                <a16:creationId xmlns:a16="http://schemas.microsoft.com/office/drawing/2014/main" id="{C286A8BF-8E1A-C4BC-EAF3-EE7C5981CB8B}"/>
              </a:ext>
            </a:extLst>
          </p:cNvPr>
          <p:cNvSpPr/>
          <p:nvPr/>
        </p:nvSpPr>
        <p:spPr>
          <a:xfrm>
            <a:off x="9959430" y="2468077"/>
            <a:ext cx="1653449" cy="662696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ative study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箭头连接符 111">
            <a:extLst>
              <a:ext uri="{FF2B5EF4-FFF2-40B4-BE49-F238E27FC236}">
                <a16:creationId xmlns:a16="http://schemas.microsoft.com/office/drawing/2014/main" id="{2F5A195B-9E1F-5A7B-CEA3-CEDDB6102387}"/>
              </a:ext>
            </a:extLst>
          </p:cNvPr>
          <p:cNvCxnSpPr>
            <a:stCxn id="17" idx="3"/>
            <a:endCxn id="18" idx="1"/>
          </p:cNvCxnSpPr>
          <p:nvPr/>
        </p:nvCxnSpPr>
        <p:spPr>
          <a:xfrm>
            <a:off x="9784832" y="2799425"/>
            <a:ext cx="174598" cy="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矩形 112">
            <a:extLst>
              <a:ext uri="{FF2B5EF4-FFF2-40B4-BE49-F238E27FC236}">
                <a16:creationId xmlns:a16="http://schemas.microsoft.com/office/drawing/2014/main" id="{A7414B6F-B830-BCDB-32C4-FDA7EB871BB3}"/>
              </a:ext>
            </a:extLst>
          </p:cNvPr>
          <p:cNvSpPr/>
          <p:nvPr/>
        </p:nvSpPr>
        <p:spPr>
          <a:xfrm>
            <a:off x="8625977" y="3302646"/>
            <a:ext cx="1158855" cy="662696"/>
          </a:xfrm>
          <a:prstGeom prst="rect">
            <a:avLst/>
          </a:prstGeom>
          <a:solidFill>
            <a:srgbClr val="DEEB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gt; 16 CR/PR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113">
            <a:extLst>
              <a:ext uri="{FF2B5EF4-FFF2-40B4-BE49-F238E27FC236}">
                <a16:creationId xmlns:a16="http://schemas.microsoft.com/office/drawing/2014/main" id="{2A747532-F675-41D5-ABFE-89B03DCAB57C}"/>
              </a:ext>
            </a:extLst>
          </p:cNvPr>
          <p:cNvSpPr/>
          <p:nvPr/>
        </p:nvSpPr>
        <p:spPr>
          <a:xfrm>
            <a:off x="9959430" y="3302646"/>
            <a:ext cx="1653449" cy="662696"/>
          </a:xfrm>
          <a:prstGeom prst="rect">
            <a:avLst/>
          </a:prstGeom>
          <a:solidFill>
            <a:srgbClr val="DEEB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endpoint reached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箭头连接符 114">
            <a:extLst>
              <a:ext uri="{FF2B5EF4-FFF2-40B4-BE49-F238E27FC236}">
                <a16:creationId xmlns:a16="http://schemas.microsoft.com/office/drawing/2014/main" id="{0E06B127-59F0-A860-A380-A23DD9E7EC32}"/>
              </a:ext>
            </a:extLst>
          </p:cNvPr>
          <p:cNvCxnSpPr>
            <a:stCxn id="20" idx="3"/>
            <a:endCxn id="21" idx="1"/>
          </p:cNvCxnSpPr>
          <p:nvPr/>
        </p:nvCxnSpPr>
        <p:spPr>
          <a:xfrm>
            <a:off x="9784832" y="3633994"/>
            <a:ext cx="174598" cy="0"/>
          </a:xfrm>
          <a:prstGeom prst="straightConnector1">
            <a:avLst/>
          </a:prstGeom>
          <a:ln>
            <a:solidFill>
              <a:srgbClr val="5B9BD5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肘形连接符 115">
            <a:extLst>
              <a:ext uri="{FF2B5EF4-FFF2-40B4-BE49-F238E27FC236}">
                <a16:creationId xmlns:a16="http://schemas.microsoft.com/office/drawing/2014/main" id="{54B428C5-F0BD-9E16-3425-A22905A24733}"/>
              </a:ext>
            </a:extLst>
          </p:cNvPr>
          <p:cNvCxnSpPr>
            <a:stCxn id="14" idx="3"/>
            <a:endCxn id="17" idx="1"/>
          </p:cNvCxnSpPr>
          <p:nvPr/>
        </p:nvCxnSpPr>
        <p:spPr>
          <a:xfrm flipV="1">
            <a:off x="8257225" y="2799425"/>
            <a:ext cx="368751" cy="445806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肘形连接符 116">
            <a:extLst>
              <a:ext uri="{FF2B5EF4-FFF2-40B4-BE49-F238E27FC236}">
                <a16:creationId xmlns:a16="http://schemas.microsoft.com/office/drawing/2014/main" id="{D66E8DD4-66DB-4A29-68AC-E74D2BEBE733}"/>
              </a:ext>
            </a:extLst>
          </p:cNvPr>
          <p:cNvCxnSpPr>
            <a:stCxn id="14" idx="3"/>
            <a:endCxn id="20" idx="1"/>
          </p:cNvCxnSpPr>
          <p:nvPr/>
        </p:nvCxnSpPr>
        <p:spPr>
          <a:xfrm>
            <a:off x="8257225" y="3245231"/>
            <a:ext cx="368751" cy="388763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122">
            <a:extLst>
              <a:ext uri="{FF2B5EF4-FFF2-40B4-BE49-F238E27FC236}">
                <a16:creationId xmlns:a16="http://schemas.microsoft.com/office/drawing/2014/main" id="{4DD4E89D-847A-706D-7B51-02D94FE308A6}"/>
              </a:ext>
            </a:extLst>
          </p:cNvPr>
          <p:cNvCxnSpPr>
            <a:cxnSpLocks/>
          </p:cNvCxnSpPr>
          <p:nvPr/>
        </p:nvCxnSpPr>
        <p:spPr>
          <a:xfrm>
            <a:off x="217170" y="1355822"/>
            <a:ext cx="6368419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123">
            <a:extLst>
              <a:ext uri="{FF2B5EF4-FFF2-40B4-BE49-F238E27FC236}">
                <a16:creationId xmlns:a16="http://schemas.microsoft.com/office/drawing/2014/main" id="{DCFBE4D3-A3FF-533A-38B8-FA61C288BA8A}"/>
              </a:ext>
            </a:extLst>
          </p:cNvPr>
          <p:cNvCxnSpPr/>
          <p:nvPr/>
        </p:nvCxnSpPr>
        <p:spPr>
          <a:xfrm>
            <a:off x="6760188" y="1355822"/>
            <a:ext cx="4852691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124">
            <a:extLst>
              <a:ext uri="{FF2B5EF4-FFF2-40B4-BE49-F238E27FC236}">
                <a16:creationId xmlns:a16="http://schemas.microsoft.com/office/drawing/2014/main" id="{227A03E1-A75E-05BB-BC12-6FC429C8E0FF}"/>
              </a:ext>
            </a:extLst>
          </p:cNvPr>
          <p:cNvSpPr txBox="1"/>
          <p:nvPr/>
        </p:nvSpPr>
        <p:spPr>
          <a:xfrm>
            <a:off x="3234828" y="969801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tage I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125">
            <a:extLst>
              <a:ext uri="{FF2B5EF4-FFF2-40B4-BE49-F238E27FC236}">
                <a16:creationId xmlns:a16="http://schemas.microsoft.com/office/drawing/2014/main" id="{997B3BC5-E05A-009B-7B99-D479ECA432B9}"/>
              </a:ext>
            </a:extLst>
          </p:cNvPr>
          <p:cNvSpPr txBox="1"/>
          <p:nvPr/>
        </p:nvSpPr>
        <p:spPr>
          <a:xfrm>
            <a:off x="8957447" y="965642"/>
            <a:ext cx="915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tage II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5D32ADE-5F5A-199B-CA5B-EE2F01A88FC1}"/>
              </a:ext>
            </a:extLst>
          </p:cNvPr>
          <p:cNvSpPr txBox="1"/>
          <p:nvPr/>
        </p:nvSpPr>
        <p:spPr>
          <a:xfrm>
            <a:off x="3694683" y="4378108"/>
            <a:ext cx="805417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rimary endpoint:</a:t>
            </a:r>
            <a:r>
              <a:rPr lang="en-US" altLang="zh-CN" sz="16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Investigator-confirmed ORR</a:t>
            </a:r>
            <a:endParaRPr lang="en-US" altLang="zh-CN" sz="1600" dirty="0">
              <a:solidFill>
                <a:schemeClr val="dk1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  <a:p>
            <a:r>
              <a:rPr lang="en-US" altLang="zh-CN" sz="16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ary endpoints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CR, PFS, OS, TTR, DOR, safety</a:t>
            </a:r>
            <a:endParaRPr lang="en-US" altLang="zh-CN" sz="1600" baseline="30000" dirty="0">
              <a:solidFill>
                <a:srgbClr val="FF0000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1F43912-FA7C-226F-415B-31B10B4DDA3C}"/>
              </a:ext>
            </a:extLst>
          </p:cNvPr>
          <p:cNvSpPr txBox="1"/>
          <p:nvPr/>
        </p:nvSpPr>
        <p:spPr>
          <a:xfrm>
            <a:off x="247871" y="5414538"/>
            <a:ext cx="1022494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l">
              <a:spcBef>
                <a:spcPts val="0"/>
              </a:spcBef>
            </a:pPr>
            <a:r>
              <a:rPr lang="en-US" sz="10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Century" panose="02040604050505020304" pitchFamily="18" charset="0"/>
              </a:rPr>
              <a:t>*Patients with T790M mutation must have received </a:t>
            </a:r>
            <a:r>
              <a:rPr lang="en-US" sz="1000" kern="1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Century" panose="02040604050505020304" pitchFamily="18" charset="0"/>
              </a:rPr>
              <a:t>osimertinib</a:t>
            </a:r>
            <a:r>
              <a:rPr lang="en-US" sz="10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Century" panose="02040604050505020304" pitchFamily="18" charset="0"/>
              </a:rPr>
              <a:t> or other approved third-generation EGFR-TKI.</a:t>
            </a:r>
            <a:endParaRPr lang="en-US" sz="1000" kern="100" dirty="0">
              <a:effectLst/>
              <a:latin typeface="Century" panose="02040604050505020304" pitchFamily="18" charset="0"/>
              <a:ea typeface="DengXian" panose="020B0503020204020204" pitchFamily="2" charset="-122"/>
              <a:cs typeface="Century" panose="02040604050505020304" pitchFamily="18" charset="0"/>
            </a:endParaRPr>
          </a:p>
          <a:p>
            <a:pPr marL="0" marR="0" algn="l">
              <a:spcBef>
                <a:spcPts val="0"/>
              </a:spcBef>
            </a:pPr>
            <a:r>
              <a:rPr lang="en-US" sz="1000" kern="1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Century" panose="02040604050505020304" pitchFamily="18" charset="0"/>
              </a:rPr>
              <a:t>†</a:t>
            </a:r>
            <a:r>
              <a:rPr lang="en-US" sz="10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Century" panose="02040604050505020304" pitchFamily="18" charset="0"/>
              </a:rPr>
              <a:t>Invasive tumor cells or tumor-infiltrating immune cells.</a:t>
            </a:r>
            <a:endParaRPr lang="en-US" sz="1000" kern="100" dirty="0">
              <a:effectLst/>
              <a:latin typeface="Century" panose="02040604050505020304" pitchFamily="18" charset="0"/>
              <a:ea typeface="DengXian" panose="020B0503020204020204" pitchFamily="2" charset="-122"/>
              <a:cs typeface="Century" panose="02040604050505020304" pitchFamily="18" charset="0"/>
            </a:endParaRPr>
          </a:p>
          <a:p>
            <a:pPr marL="0" marR="0" algn="l">
              <a:spcBef>
                <a:spcPts val="0"/>
              </a:spcBef>
            </a:pPr>
            <a:r>
              <a:rPr lang="en-US" sz="1000" kern="1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Century" panose="02040604050505020304" pitchFamily="18" charset="0"/>
              </a:rPr>
              <a:t>‡</a:t>
            </a:r>
            <a:r>
              <a:rPr lang="en-US" sz="10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Century" panose="02040604050505020304" pitchFamily="18" charset="0"/>
              </a:rPr>
              <a:t>Study treatment continued until progressive disease (per RECIST 1.1), unacceptable toxicity, or death.</a:t>
            </a:r>
            <a:endParaRPr lang="en-US" sz="1000" kern="100" dirty="0">
              <a:effectLst/>
              <a:latin typeface="Century" panose="02040604050505020304" pitchFamily="18" charset="0"/>
              <a:ea typeface="DengXian" panose="020B0503020204020204" pitchFamily="2" charset="-122"/>
              <a:cs typeface="Century" panose="02040604050505020304" pitchFamily="18" charset="0"/>
            </a:endParaRPr>
          </a:p>
          <a:p>
            <a:pPr marL="0" marR="0" algn="l">
              <a:spcBef>
                <a:spcPts val="0"/>
              </a:spcBef>
            </a:pPr>
            <a:r>
              <a:rPr lang="en-US" sz="1000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Century" panose="02040604050505020304" pitchFamily="18" charset="0"/>
              </a:rPr>
              <a:t>CR, complete response; DCR, disease control rate; DOR, duration of response; ECOG, Easter Cooperative Oncology Group; EGFR-TKI, epidermal growth factor receptor-tyrosine kinase inhibitor; NSCLC, non-small cell lung cancer; ORR, overall response rate; OS, overall survival; PD-L1, programmed death ligand-1; PFS, progression-free survival; PR, partial response; Q3W, every 3 weeks; RECIST, Response Evaluation Criteria In Solid Tumors; TTR, time to response.</a:t>
            </a:r>
            <a:endParaRPr lang="en-US" sz="1000" kern="100" dirty="0">
              <a:effectLst/>
              <a:latin typeface="Century" panose="02040604050505020304" pitchFamily="18" charset="0"/>
              <a:ea typeface="DengXian" panose="020B0503020204020204" pitchFamily="2" charset="-122"/>
              <a:cs typeface="Century" panose="02040604050505020304" pitchFamily="18" charset="0"/>
            </a:endParaRPr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171989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7</TotalTime>
  <Words>222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</vt:lpstr>
      <vt:lpstr>Arial</vt:lpstr>
      <vt:lpstr>Calibri</vt:lpstr>
      <vt:lpstr>Calibri Light</vt:lpstr>
      <vt:lpstr>Century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dical Writer</dc:creator>
  <cp:lastModifiedBy>Yu, Jack {MWAM~SHANGHAI}</cp:lastModifiedBy>
  <cp:revision>23</cp:revision>
  <dcterms:created xsi:type="dcterms:W3CDTF">2023-03-05T22:23:31Z</dcterms:created>
  <dcterms:modified xsi:type="dcterms:W3CDTF">2024-04-18T08:00:16Z</dcterms:modified>
</cp:coreProperties>
</file>